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10" d="100"/>
          <a:sy n="110" d="100"/>
        </p:scale>
        <p:origin x="1378" y="-343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0E6767-9279-9878-AB9C-4070219D37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6B6D34-A6EA-B644-E316-9058538227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70801-37C0-0F5C-BAB6-E41549F24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EA34E5-5A87-ECA3-8C62-EEB198126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D622E-8B7E-E0CC-CB7E-2C67E458C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807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B657D-5558-C834-389D-EC2E64119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D60CCB-87DC-639C-F7F1-84404EA4F5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D77CC-5F26-748D-B5BD-A111B6A5E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37D91A-48FB-D706-4AED-95C6B626E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45176-C92F-93D5-EACC-22931836C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2418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270B49-8D94-902F-C551-4F6BFEDB52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457446-F633-C8C7-13F0-5490591A21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7ACE57-58FF-DF2B-72D3-5FD38CAB6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E2225-1772-4DF5-2EE8-CCDBD2C1A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30FB37-0C86-0820-8EF3-E85858869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50047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820A7-E0A4-B012-CDCF-2A24EEB63C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195028-7947-B6E1-08ED-CA6ABCE9BE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22C85-05EA-D0A9-64FF-8426EDF6D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49A3B1-5180-DCFA-1FEB-E4930AC0C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3447E1-4C51-6FF4-466D-4E7D4B4C1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84306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50CFBD-251F-D552-D233-7700F8F604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546C1F-F696-73B9-9C62-F644AE432A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7FB24-1E66-3AA9-6109-1883FCE9C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D31B7-563B-5956-044D-D42016B9A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90EAF7-4AC5-D7C9-20D5-60D261E29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8074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7C4D4-F7FF-29D4-37D0-107A64217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217993-F533-F0C8-4D7D-B6B738CADF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C225D6-18A1-4A75-AA18-D10F6BEA3F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C9EBAF-5AB6-2990-345B-B47FCB294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E7F2EE-9053-AD6E-5508-0FF6B122B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F9EAD-01C1-12A0-A5F3-A9F311BF6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1016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304A8-37C4-03DF-8E06-B44B57582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5E09F5-CF93-518D-0231-5D12981E71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D42D10-894A-777C-E6B6-F08936EEF1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BBAA46-34C2-EBE9-7F78-90808054B3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3F78A6-9481-4A0B-81FC-B8A1CC23B0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209FC8-B3F6-7EB9-77C4-776C3399E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D7A9C6-1E66-E00B-7E28-88C51EA04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46F2F7-9721-7EEB-D0F4-2A6CE03D1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748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9B1E5-CB85-D371-7F34-8CBE3ACEF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64F9B6-D77F-B7F6-F1D5-41B8FB71F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4122EB-1445-8EDB-E023-F3D313EA1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41209E-1061-465C-CDDE-333B63CF4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0945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333F34-3E9F-B686-7117-5DCDCB407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B53DB1-5EBF-6C3C-CC6C-381FB2D6C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011D2F-6B35-A81E-A046-A12623924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8616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7BAD8-77CE-A5F6-2029-4F605BA95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C86347-28C3-266C-F37E-CB30507DBB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43ED23-ECEF-77CB-4BE0-7EBE65023C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825FC1-EB9B-04E1-93F8-E9F5371F8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021779-4F60-6A3D-240B-CA6C3FA6B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325D03-319F-093F-7DC7-9BB6A8648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4567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3F69A-72E4-4E23-D390-1A27BD83AA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D7D0AD-0A8A-DF67-BA42-87F8E4B03F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65147D-7E0F-BDC9-5831-7A03D583C8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F23D5B-D8BD-90E4-417C-4A6A92073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A959E5-40A5-2FCA-14DA-81CF1DB4A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945727-4C8C-5397-9B21-5417C3C0D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368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4B4762-B63A-E450-D4C4-2AF0FB0E8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333B5F-5D5B-DE58-6934-A6AB994A5B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548F8-3DAC-3ACD-94AF-44343805CB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429730-E13D-45DF-9C4C-D53DA1FF648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98805D-CB94-50BB-5836-1905B3943D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56CCFB-19E0-CC59-F419-D98646F606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080170-E1FF-4F01-A7E1-326E1AA650A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0630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D5C9B66-E727-F12B-CF5C-E3AF7E80930C}"/>
              </a:ext>
            </a:extLst>
          </p:cNvPr>
          <p:cNvSpPr txBox="1"/>
          <p:nvPr/>
        </p:nvSpPr>
        <p:spPr>
          <a:xfrm>
            <a:off x="685800" y="8017295"/>
            <a:ext cx="55626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3. </a:t>
            </a:r>
            <a:r>
              <a:rPr lang="en-IN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Comparison of amino acid sequences of LsTPS8. Deduced amino acid sequences from this study were aligned with that from Phytozome database.</a:t>
            </a:r>
            <a:endParaRPr lang="en-IN" sz="10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70FAD67-E8DA-99D6-CF8F-5A38FAA8F5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4402" y="505896"/>
            <a:ext cx="4469195" cy="7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1378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ileshwar Singh</dc:creator>
  <cp:lastModifiedBy>Sungbeom Lee</cp:lastModifiedBy>
  <cp:revision>7</cp:revision>
  <dcterms:created xsi:type="dcterms:W3CDTF">2025-11-12T01:31:13Z</dcterms:created>
  <dcterms:modified xsi:type="dcterms:W3CDTF">2025-12-03T03:35:24Z</dcterms:modified>
</cp:coreProperties>
</file>